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808" autoAdjust="0"/>
    <p:restoredTop sz="94660"/>
  </p:normalViewPr>
  <p:slideViewPr>
    <p:cSldViewPr snapToObjects="1">
      <p:cViewPr>
        <p:scale>
          <a:sx n="75" d="100"/>
          <a:sy n="75" d="100"/>
        </p:scale>
        <p:origin x="-2160" y="-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7366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3679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2052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794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9109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1857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9783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3718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7026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4377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0031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FD6958-7973-42F5-8463-9E11B8C57504}" type="datetimeFigureOut">
              <a:rPr lang="en-GB" smtClean="0"/>
              <a:t>07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06F87-73A2-450D-B75F-B074696A7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703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667"/>
            <a:ext cx="29236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smtClean="0">
                <a:latin typeface="Arial" panose="020B0604020202020204" pitchFamily="34" charset="0"/>
                <a:cs typeface="Arial" panose="020B0604020202020204" pitchFamily="34" charset="0"/>
              </a:rPr>
              <a:t>S1 Table.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tails of lens donors 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9449699"/>
              </p:ext>
            </p:extLst>
          </p:nvPr>
        </p:nvGraphicFramePr>
        <p:xfrm>
          <a:off x="116632" y="308444"/>
          <a:ext cx="3600400" cy="5343525"/>
        </p:xfrm>
        <a:graphic>
          <a:graphicData uri="http://schemas.openxmlformats.org/drawingml/2006/table">
            <a:tbl>
              <a:tblPr>
                <a:tableStyleId>{7E9639D4-E3E2-4D34-9284-5A2195B3D0D7}</a:tableStyleId>
              </a:tblPr>
              <a:tblGrid>
                <a:gridCol w="689438"/>
                <a:gridCol w="459626"/>
                <a:gridCol w="995855"/>
                <a:gridCol w="1455481"/>
              </a:tblGrid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 smtClean="0">
                          <a:effectLst/>
                        </a:rPr>
                        <a:t>Age (years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</a:rPr>
                        <a:t>Gender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</a:rPr>
                        <a:t>Smoking Status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</a:rPr>
                        <a:t>Cause of Death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lioblastom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liom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Unknow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Unknow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ntracranial hemorrhag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Unknow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Epleptic fit/Cardiac arres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Unknow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Unknow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Unknow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4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Unknow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Cardiac arres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4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F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ubarachnoid hemorrhage 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Unknow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ntracranial hemorrhag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n-Smok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Traum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Alcoholic liver diseas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Alcoholic liver diseas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nfections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Cerebrovascular accident 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Canc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6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ntracranial hemorrhag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ntracranial hemorrhag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n-Smok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ntracranial hemorrhag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Multi organ failur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ntracranial hemorrhag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Lung Canc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n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information availab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477420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93</TotalTime>
  <Words>189</Words>
  <Application>Microsoft Office PowerPoint</Application>
  <PresentationFormat>A4 Paper (210x297 mm)</PresentationFormat>
  <Paragraphs>1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 Langford-Smith</dc:creator>
  <cp:lastModifiedBy>Alex Langford-Smith</cp:lastModifiedBy>
  <cp:revision>139</cp:revision>
  <cp:lastPrinted>2015-10-09T13:12:14Z</cp:lastPrinted>
  <dcterms:created xsi:type="dcterms:W3CDTF">2015-02-25T20:38:22Z</dcterms:created>
  <dcterms:modified xsi:type="dcterms:W3CDTF">2016-01-07T17:44:56Z</dcterms:modified>
</cp:coreProperties>
</file>